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96" y="5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S$97</c:f>
              <c:strCache>
                <c:ptCount val="1"/>
                <c:pt idx="0">
                  <c:v>ICBT-group tot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V$98:$V$99</c:f>
                <c:numCache>
                  <c:formatCode>General</c:formatCode>
                  <c:ptCount val="2"/>
                  <c:pt idx="0">
                    <c:v>8.4630579329780815</c:v>
                  </c:pt>
                  <c:pt idx="1">
                    <c:v>6.3098781306389711</c:v>
                  </c:pt>
                </c:numCache>
              </c:numRef>
            </c:plus>
            <c:minus>
              <c:numRef>
                <c:f>Blad1!$V$98:$V$99</c:f>
                <c:numCache>
                  <c:formatCode>General</c:formatCode>
                  <c:ptCount val="2"/>
                  <c:pt idx="0">
                    <c:v>8.4630579329780815</c:v>
                  </c:pt>
                  <c:pt idx="1">
                    <c:v>6.30987813063897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S$98:$S$99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T$98:$T$99</c:f>
              <c:numCache>
                <c:formatCode>###0\.00</c:formatCode>
                <c:ptCount val="2"/>
                <c:pt idx="0" formatCode="General">
                  <c:v>41.76</c:v>
                </c:pt>
                <c:pt idx="1">
                  <c:v>35.76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W$97</c:f>
              <c:strCache>
                <c:ptCount val="1"/>
                <c:pt idx="0">
                  <c:v>DF-group total</c:v>
                </c:pt>
              </c:strCache>
            </c:strRef>
          </c:tx>
          <c:spPr>
            <a:ln w="285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Z$98:$Z$99</c:f>
                <c:numCache>
                  <c:formatCode>General</c:formatCode>
                  <c:ptCount val="2"/>
                  <c:pt idx="0">
                    <c:v>9.8818873255092043</c:v>
                  </c:pt>
                  <c:pt idx="1">
                    <c:v>8.8113322788243451</c:v>
                  </c:pt>
                </c:numCache>
              </c:numRef>
            </c:plus>
            <c:minus>
              <c:numRef>
                <c:f>Blad1!$Z$98:$Z$99</c:f>
                <c:numCache>
                  <c:formatCode>General</c:formatCode>
                  <c:ptCount val="2"/>
                  <c:pt idx="0">
                    <c:v>9.8818873255092043</c:v>
                  </c:pt>
                  <c:pt idx="1">
                    <c:v>8.81133227882434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X$98:$X$99</c:f>
              <c:numCache>
                <c:formatCode>###0\.0000</c:formatCode>
                <c:ptCount val="2"/>
                <c:pt idx="0">
                  <c:v>47.115000000000002</c:v>
                </c:pt>
                <c:pt idx="1">
                  <c:v>45.2624390243902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26601288"/>
        <c:axId val="326601680"/>
      </c:lineChart>
      <c:catAx>
        <c:axId val="326601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6601680"/>
        <c:crosses val="autoZero"/>
        <c:auto val="1"/>
        <c:lblAlgn val="ctr"/>
        <c:lblOffset val="100"/>
        <c:noMultiLvlLbl val="0"/>
      </c:catAx>
      <c:valAx>
        <c:axId val="326601680"/>
        <c:scaling>
          <c:orientation val="minMax"/>
          <c:max val="60"/>
          <c:min val="2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MLHF -</a:t>
                </a:r>
                <a:r>
                  <a:rPr lang="sv-SE" baseline="0" dirty="0" smtClean="0">
                    <a:solidFill>
                      <a:schemeClr val="tx1"/>
                    </a:solidFill>
                  </a:rPr>
                  <a:t> Total</a:t>
                </a:r>
                <a:endParaRPr lang="sv-SE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6601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S$105</c:f>
              <c:strCache>
                <c:ptCount val="1"/>
                <c:pt idx="0">
                  <c:v>ICBT-group Emo.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V$106:$V$107</c:f>
                <c:numCache>
                  <c:formatCode>General</c:formatCode>
                  <c:ptCount val="2"/>
                  <c:pt idx="0">
                    <c:v>2.9542841354981837</c:v>
                  </c:pt>
                  <c:pt idx="1">
                    <c:v>2.6522887402957389</c:v>
                  </c:pt>
                </c:numCache>
              </c:numRef>
            </c:plus>
            <c:minus>
              <c:numRef>
                <c:f>Blad1!$V$106:$V$107</c:f>
                <c:numCache>
                  <c:formatCode>General</c:formatCode>
                  <c:ptCount val="2"/>
                  <c:pt idx="0">
                    <c:v>2.9542841354981837</c:v>
                  </c:pt>
                  <c:pt idx="1">
                    <c:v>2.65228874029573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S$106:$S$107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T$106:$T$107</c:f>
              <c:numCache>
                <c:formatCode>###0\.0000</c:formatCode>
                <c:ptCount val="2"/>
                <c:pt idx="0">
                  <c:v>10.84</c:v>
                </c:pt>
                <c:pt idx="1">
                  <c:v>10.509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W$105</c:f>
              <c:strCache>
                <c:ptCount val="1"/>
                <c:pt idx="0">
                  <c:v>DF-group Emo.</c:v>
                </c:pt>
              </c:strCache>
            </c:strRef>
          </c:tx>
          <c:spPr>
            <a:ln w="285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Z$106:$Z$107</c:f>
                <c:numCache>
                  <c:formatCode>General</c:formatCode>
                  <c:ptCount val="2"/>
                  <c:pt idx="0">
                    <c:v>2.5829740182881586</c:v>
                  </c:pt>
                  <c:pt idx="1">
                    <c:v>2.3123635778861509</c:v>
                  </c:pt>
                </c:numCache>
              </c:numRef>
            </c:plus>
            <c:minus>
              <c:numRef>
                <c:f>Blad1!$Z$106:$Z$107</c:f>
                <c:numCache>
                  <c:formatCode>General</c:formatCode>
                  <c:ptCount val="2"/>
                  <c:pt idx="0">
                    <c:v>2.5829740182881586</c:v>
                  </c:pt>
                  <c:pt idx="1">
                    <c:v>2.31236357788615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X$106:$X$107</c:f>
              <c:numCache>
                <c:formatCode>###0\.0000</c:formatCode>
                <c:ptCount val="2"/>
                <c:pt idx="0">
                  <c:v>13.701666666666668</c:v>
                </c:pt>
                <c:pt idx="1">
                  <c:v>12.85658536585365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26602464"/>
        <c:axId val="326602856"/>
      </c:lineChart>
      <c:catAx>
        <c:axId val="326602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6602856"/>
        <c:crosses val="autoZero"/>
        <c:auto val="1"/>
        <c:lblAlgn val="ctr"/>
        <c:lblOffset val="100"/>
        <c:noMultiLvlLbl val="0"/>
      </c:catAx>
      <c:valAx>
        <c:axId val="326602856"/>
        <c:scaling>
          <c:orientation val="minMax"/>
          <c:min val="7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MLHF – Emotional </a:t>
                </a:r>
                <a:r>
                  <a:rPr lang="sv-SE" dirty="0" err="1" smtClean="0">
                    <a:solidFill>
                      <a:schemeClr val="tx1"/>
                    </a:solidFill>
                  </a:rPr>
                  <a:t>factor</a:t>
                </a:r>
                <a:r>
                  <a:rPr lang="sv-SE" dirty="0" smtClean="0">
                    <a:solidFill>
                      <a:schemeClr val="tx1"/>
                    </a:solidFill>
                  </a:rPr>
                  <a:t> </a:t>
                </a:r>
                <a:endParaRPr lang="sv-SE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6602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S$101</c:f>
              <c:strCache>
                <c:ptCount val="1"/>
                <c:pt idx="0">
                  <c:v>ICBT-group Phys.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V$102:$V$103</c:f>
                <c:numCache>
                  <c:formatCode>General</c:formatCode>
                  <c:ptCount val="2"/>
                  <c:pt idx="0">
                    <c:v>3.6066492034650146</c:v>
                  </c:pt>
                  <c:pt idx="1">
                    <c:v>3.1183310560535169</c:v>
                  </c:pt>
                </c:numCache>
              </c:numRef>
            </c:plus>
            <c:minus>
              <c:numRef>
                <c:f>Blad1!$V$102:$V$103</c:f>
                <c:numCache>
                  <c:formatCode>General</c:formatCode>
                  <c:ptCount val="2"/>
                  <c:pt idx="0">
                    <c:v>3.6066492034650146</c:v>
                  </c:pt>
                  <c:pt idx="1">
                    <c:v>3.11833105605351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S$102:$S$103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T$102:$T$103</c:f>
              <c:numCache>
                <c:formatCode>###0\.0000</c:formatCode>
                <c:ptCount val="2"/>
                <c:pt idx="0">
                  <c:v>17.48</c:v>
                </c:pt>
                <c:pt idx="1">
                  <c:v>15.15414634146341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W$101</c:f>
              <c:strCache>
                <c:ptCount val="1"/>
                <c:pt idx="0">
                  <c:v>DF-group Phys.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Z$102:$Z$103</c:f>
                <c:numCache>
                  <c:formatCode>General</c:formatCode>
                  <c:ptCount val="2"/>
                  <c:pt idx="0">
                    <c:v>4.3580512820290522</c:v>
                  </c:pt>
                  <c:pt idx="1">
                    <c:v>3.670684353477963</c:v>
                  </c:pt>
                </c:numCache>
              </c:numRef>
            </c:plus>
            <c:minus>
              <c:numRef>
                <c:f>Blad1!$Z$102:$Z$103</c:f>
                <c:numCache>
                  <c:formatCode>General</c:formatCode>
                  <c:ptCount val="2"/>
                  <c:pt idx="0">
                    <c:v>4.3580512820290522</c:v>
                  </c:pt>
                  <c:pt idx="1">
                    <c:v>3.670684353477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X$102:$X$103</c:f>
              <c:numCache>
                <c:formatCode>###0\.0000</c:formatCode>
                <c:ptCount val="2"/>
                <c:pt idx="0">
                  <c:v>19.9783333333333</c:v>
                </c:pt>
                <c:pt idx="1">
                  <c:v>19.7726829268293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22953680"/>
        <c:axId val="222954072"/>
      </c:lineChart>
      <c:catAx>
        <c:axId val="222953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22954072"/>
        <c:crosses val="autoZero"/>
        <c:auto val="1"/>
        <c:lblAlgn val="ctr"/>
        <c:lblOffset val="100"/>
        <c:noMultiLvlLbl val="0"/>
      </c:catAx>
      <c:valAx>
        <c:axId val="222954072"/>
        <c:scaling>
          <c:orientation val="minMax"/>
          <c:max val="25"/>
          <c:min val="11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MLHF</a:t>
                </a:r>
                <a:r>
                  <a:rPr lang="sv-SE" baseline="0" dirty="0" smtClean="0">
                    <a:solidFill>
                      <a:schemeClr val="tx1"/>
                    </a:solidFill>
                  </a:rPr>
                  <a:t> – </a:t>
                </a:r>
                <a:r>
                  <a:rPr lang="en-US" baseline="0" noProof="0" dirty="0" smtClean="0">
                    <a:solidFill>
                      <a:schemeClr val="tx1"/>
                    </a:solidFill>
                  </a:rPr>
                  <a:t>Physical factor</a:t>
                </a:r>
                <a:endParaRPr lang="en-US" noProof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22953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49453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87612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2007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74705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17156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63377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9694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1138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91853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39877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6238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7E06B-A9AF-4E5C-A488-85812E9CCD6F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095DF-175E-478F-85D8-D30FED3266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58480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sv-SE" sz="2400" dirty="0" smtClean="0"/>
              <a:t>Multimedia </a:t>
            </a:r>
            <a:r>
              <a:rPr lang="sv-SE" sz="2400" smtClean="0"/>
              <a:t>appendix </a:t>
            </a:r>
            <a:r>
              <a:rPr lang="sv-SE" sz="2400" smtClean="0"/>
              <a:t>4:</a:t>
            </a:r>
            <a:r>
              <a:rPr lang="en-US" sz="2400" smtClean="0"/>
              <a:t> </a:t>
            </a:r>
            <a:r>
              <a:rPr lang="en-US" sz="2400" dirty="0"/>
              <a:t>Change in Minnesota Living with Heart Failure (MLHF) – total score and factors in the two groups (n=25 ICBT and n=25 DF)</a:t>
            </a:r>
            <a:r>
              <a:rPr lang="sv-SE" sz="2400" dirty="0"/>
              <a:t/>
            </a:r>
            <a:br>
              <a:rPr lang="sv-SE" sz="2400" dirty="0"/>
            </a:br>
            <a:endParaRPr lang="sv-SE" sz="2400" dirty="0"/>
          </a:p>
        </p:txBody>
      </p:sp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5055220"/>
              </p:ext>
            </p:extLst>
          </p:nvPr>
        </p:nvGraphicFramePr>
        <p:xfrm>
          <a:off x="0" y="1471272"/>
          <a:ext cx="4180114" cy="2986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2856968"/>
              </p:ext>
            </p:extLst>
          </p:nvPr>
        </p:nvGraphicFramePr>
        <p:xfrm>
          <a:off x="8000998" y="1471272"/>
          <a:ext cx="3799115" cy="2986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Diagra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8319841"/>
              </p:ext>
            </p:extLst>
          </p:nvPr>
        </p:nvGraphicFramePr>
        <p:xfrm>
          <a:off x="4125685" y="1471272"/>
          <a:ext cx="3929743" cy="2986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2" name="Grupp 11"/>
          <p:cNvGrpSpPr/>
          <p:nvPr/>
        </p:nvGrpSpPr>
        <p:grpSpPr>
          <a:xfrm>
            <a:off x="10494061" y="4714720"/>
            <a:ext cx="1228725" cy="1190655"/>
            <a:chOff x="5149175" y="3767663"/>
            <a:chExt cx="1228725" cy="1190655"/>
          </a:xfrm>
        </p:grpSpPr>
        <p:cxnSp>
          <p:nvCxnSpPr>
            <p:cNvPr id="7" name="Rak 6"/>
            <p:cNvCxnSpPr/>
            <p:nvPr/>
          </p:nvCxnSpPr>
          <p:spPr>
            <a:xfrm>
              <a:off x="5149175" y="3890774"/>
              <a:ext cx="409575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Rak 7"/>
            <p:cNvCxnSpPr/>
            <p:nvPr/>
          </p:nvCxnSpPr>
          <p:spPr>
            <a:xfrm>
              <a:off x="5149175" y="4386074"/>
              <a:ext cx="409575" cy="0"/>
            </a:xfrm>
            <a:prstGeom prst="line">
              <a:avLst/>
            </a:prstGeom>
            <a:ln w="28575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ruta 8"/>
            <p:cNvSpPr txBox="1"/>
            <p:nvPr/>
          </p:nvSpPr>
          <p:spPr>
            <a:xfrm>
              <a:off x="5580750" y="3767663"/>
              <a:ext cx="797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ICBT-group</a:t>
              </a:r>
              <a:endParaRPr lang="en-US" sz="1000" dirty="0"/>
            </a:p>
          </p:txBody>
        </p:sp>
        <p:sp>
          <p:nvSpPr>
            <p:cNvPr id="10" name="textruta 9"/>
            <p:cNvSpPr txBox="1"/>
            <p:nvPr/>
          </p:nvSpPr>
          <p:spPr>
            <a:xfrm>
              <a:off x="5580750" y="4262963"/>
              <a:ext cx="6733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DF-group</a:t>
              </a:r>
              <a:endParaRPr lang="en-US" sz="1000" dirty="0"/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5149175" y="4558208"/>
              <a:ext cx="122872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Error-bars representing 95% CI</a:t>
              </a:r>
              <a:endParaRPr lang="en-US" sz="1000" dirty="0"/>
            </a:p>
          </p:txBody>
        </p:sp>
      </p:grpSp>
      <p:sp>
        <p:nvSpPr>
          <p:cNvPr id="13" name="Rektangel 12"/>
          <p:cNvSpPr/>
          <p:nvPr/>
        </p:nvSpPr>
        <p:spPr>
          <a:xfrm>
            <a:off x="380999" y="4458086"/>
            <a:ext cx="94814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COVA fo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scale</a:t>
            </a:r>
            <a:r>
              <a:rPr lang="sv-S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F(1,47)=2.9, p=0.09], physical factor: [F(1,47)=3.3, p=0.07],  emotional factor: [F(1,47)=0.2, p=0.66]</a:t>
            </a:r>
            <a:endParaRPr lang="sv-S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ktangel 13"/>
          <p:cNvSpPr/>
          <p:nvPr/>
        </p:nvSpPr>
        <p:spPr>
          <a:xfrm>
            <a:off x="381000" y="4918951"/>
            <a:ext cx="9982200" cy="986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otal scale range for: MLHF Total 0-105, MLHF Physical 0-40, MLHF Emotional 0-25. </a:t>
            </a:r>
            <a:endParaRPr lang="sv-SE" sz="14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bbreviations: MLHF – Minnesota Living with Heart Failure questionnaire, Total – total scale, Physical – physical factors in MLHF, Emotional – emotional factors in MLHF, ICBT – Internet-based Cognitive behavioral therapy, DF – Discussion-Forum, CI – Confidence Interval 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1913804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142</Words>
  <Application>Microsoft Office PowerPoint</Application>
  <PresentationFormat>Bred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Multimedia appendix 4: Change in Minnesota Living with Heart Failure (MLHF) – total score and factors in the two groups (n=25 ICBT and n=25 DF) </vt:lpstr>
    </vt:vector>
  </TitlesOfParts>
  <Company>Linköpings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5: : Change in Minnesota Living with Heart Failure (MLHF) – total score and factors in the two groups (n=25 ICBT and n=25 DF)</dc:title>
  <dc:creator>Johan Lundgren</dc:creator>
  <cp:lastModifiedBy>Johan Lundgren</cp:lastModifiedBy>
  <cp:revision>4</cp:revision>
  <dcterms:created xsi:type="dcterms:W3CDTF">2016-01-17T23:32:37Z</dcterms:created>
  <dcterms:modified xsi:type="dcterms:W3CDTF">2016-06-12T15:02:21Z</dcterms:modified>
</cp:coreProperties>
</file>